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47"/>
  </p:normalViewPr>
  <p:slideViewPr>
    <p:cSldViewPr snapToGrid="0" snapToObjects="1">
      <p:cViewPr varScale="1">
        <p:scale>
          <a:sx n="133" d="100"/>
          <a:sy n="133" d="100"/>
        </p:scale>
        <p:origin x="224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5F68C-65F6-6947-8C3D-284175514C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A69921-75E3-D24D-BB5B-AEEABBA6C2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6ED900-9277-404A-A95C-EA15A4657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3D92F-ED8B-0C45-9CAD-573876E5E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C7E289-C8AD-C040-81FD-1D25DE411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70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582DF6-214E-A142-8354-D3100C87A2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2D32E8-4A85-114E-BA3D-7874497941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869BA1-8C27-F14D-8E59-5CF8BEB8F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11F3D-79F9-AD4C-88E3-1CE0CE46D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914A4E-0AEF-D14F-8F3D-FAE3001A02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302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F8922B4-B255-5F4D-8007-DBCC5E4B69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6C57FC-AB4C-9E43-8E3C-F276C0426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951D5-1869-5643-8D8B-624552F986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F21A98-F522-F045-87D0-498B0B005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BF2DF6-ED76-F04F-8AE3-6B7173904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294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6D829-C06A-BA44-832B-EAF8FA92E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8BFF5-FEFB-504F-9ADE-A6F9C21282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C2DF77-B60A-D34F-ABCF-BB4FC7306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98567A-AEFF-8D43-A77C-8F01912E7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8D0000-01EF-CF48-9212-41165D4D0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540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53F4F-C501-F24F-8C69-E928C6F415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72496A-F936-154C-9D3A-56D33F5D46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10A4F9-668A-A349-B665-2C50C8308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953B7D-124A-BB4E-AD2C-FBCF285B8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A08B2-E419-1A40-A24A-33183487B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38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69D8D-77E2-BB45-A90B-1715FEB158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2AF541-2F36-AC45-84B7-D19258D36F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0D62C9-F4D0-AA4E-84B4-42414411F3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598C8E-5364-BC4E-A4D0-9241185336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E50544-9BA2-914E-B4A9-4FDEBF151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3B6170-E11F-E340-8089-F47F45F38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170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3AE89A-3F18-4B42-BD33-82FA05E4B0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193142-AAAB-384D-9BBB-FF480F1B91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5DDCD6-01D0-2C4A-8E7D-FCC59476AC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F87C37-580E-5146-847B-9F21033C7D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69ECDD-CFA9-704F-9FF2-6B081CBEF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B1E967-27D0-6442-84DA-FA45F0833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2B4451-29EE-5A49-BCB3-DA02B7AB9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F09CC9-3ED0-BF40-BB17-3069D47D9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10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9CD3EA-0995-F84F-A2E8-5102156382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C39DEAA-A3BF-0F4E-B2CF-6C922C582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3D9CA3-D53D-E34F-8A3C-1075848BE6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E64319-9F0B-8149-AD6E-49292CB12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394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44A308-D9F7-364A-8662-9DCA8C11C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08878AB-596F-E741-9495-D3B10EFAD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E62B95-6B06-E543-A901-59A4D490FE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905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89A63-9358-F546-B015-D792C90EC9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93D2D2-1723-8B4C-9BEA-94A313F406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1F88EF-3945-2041-8E38-A92E850A06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A45E0A-6C60-AD47-9628-21F6D525A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148833-04CA-974B-A728-229CAFEC1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751C5C-03F8-8C4B-83F6-124137D25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E59B5A-EB42-4949-B7BE-72550331D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508AC9-115A-3C45-B73C-5CDDD64C31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5133DA-2343-5242-86DD-F5DCE18F5D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A1E099-9DF2-F143-AA14-6B1293BCDE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3B1A2B-8EE5-7A40-9CAB-BEB374955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7BAB8-0B16-0645-9DA6-CEC266919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791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B44D53-D58E-B146-9F19-1C7CE4752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F57201-AE17-5A44-87D9-164908EAB2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3EBB91-6BAE-DC4B-84D8-7361D1E9F9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69818-4452-9946-B7BF-963945E98C5D}" type="datetimeFigureOut">
              <a:rPr lang="en-US" smtClean="0"/>
              <a:t>5/3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796CE0-0680-1F45-8261-93B13C7FBA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9EDA4-9701-0745-B59E-E7D15495AA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CCFFCA-2549-CE46-A075-2AD387734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293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0AFB733-980A-7E46-9502-A1B9C3BEA9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4429" y="1067677"/>
            <a:ext cx="5863687" cy="31918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73B7FB8-4B98-9E4C-9B15-622D23648B87}"/>
              </a:ext>
            </a:extLst>
          </p:cNvPr>
          <p:cNvSpPr txBox="1"/>
          <p:nvPr/>
        </p:nvSpPr>
        <p:spPr>
          <a:xfrm>
            <a:off x="1118795" y="5174428"/>
            <a:ext cx="1039323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S1 Figure</a:t>
            </a:r>
            <a:r>
              <a:rPr lang="en-US" dirty="0"/>
              <a:t>.  Growth curves of the χ11802 vaccine strains used in this study.   Strains were grown with aeration </a:t>
            </a:r>
          </a:p>
          <a:p>
            <a:r>
              <a:rPr lang="en-US" dirty="0"/>
              <a:t>in LB supplemented with 0.1% arabinose and 0.1% mannose.  A. Optical density measurements; B. Colony </a:t>
            </a:r>
          </a:p>
          <a:p>
            <a:r>
              <a:rPr lang="en-US" dirty="0"/>
              <a:t>forming units obtained by serial plating onto LB + arabinose at the indicated time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ABB1BB4-CFEE-4F44-97A1-B82DBA4086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617" y="1163955"/>
            <a:ext cx="5550657" cy="29992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8E33984-0222-324C-8A94-2617C3550393}"/>
              </a:ext>
            </a:extLst>
          </p:cNvPr>
          <p:cNvSpPr txBox="1"/>
          <p:nvPr/>
        </p:nvSpPr>
        <p:spPr>
          <a:xfrm>
            <a:off x="715443" y="81792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F5060D-9343-2549-B7B8-6E60DCDDA84E}"/>
              </a:ext>
            </a:extLst>
          </p:cNvPr>
          <p:cNvSpPr txBox="1"/>
          <p:nvPr/>
        </p:nvSpPr>
        <p:spPr>
          <a:xfrm>
            <a:off x="6357769" y="82833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586082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neth Roland</dc:creator>
  <cp:lastModifiedBy>Kenneth Roland</cp:lastModifiedBy>
  <cp:revision>3</cp:revision>
  <dcterms:created xsi:type="dcterms:W3CDTF">2018-05-03T20:10:53Z</dcterms:created>
  <dcterms:modified xsi:type="dcterms:W3CDTF">2018-05-03T20:12:20Z</dcterms:modified>
</cp:coreProperties>
</file>